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78" r:id="rId3"/>
    <p:sldId id="261" r:id="rId4"/>
    <p:sldId id="279" r:id="rId5"/>
    <p:sldId id="276" r:id="rId6"/>
  </p:sldIdLst>
  <p:sldSz cx="12192000" cy="6858000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52" userDrawn="1">
          <p15:clr>
            <a:srgbClr val="A4A3A4"/>
          </p15:clr>
        </p15:guide>
        <p15:guide id="2" pos="2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126" y="312"/>
      </p:cViewPr>
      <p:guideLst>
        <p:guide orient="horz" pos="1752"/>
        <p:guide pos="21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FB4C60B-8B29-4B36-BC56-717E280C88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BB3B8CC-787D-4F5A-8D25-C1E077B0AA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86A90A1-55FC-47DA-97D8-99F0B8D00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B42582-F22C-444F-BC05-81E0B47500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CCB20A-1B87-4470-A8D0-09B21F30F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4290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8CB5AA-0649-480C-950B-1710E73C8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B356000-0E20-4E17-A1C9-0914DE066A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6A8659-E0DC-4DC7-B99E-A7AC8226A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D550950-F71D-432D-B362-BA7B873C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DBBCB5A-D507-4748-8F97-A267628C7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858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B9096FC-2FDC-4ABB-B8F0-F89DFEA7C0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286B37C-B326-4156-9B67-A0E01BF913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AFAC3BE-98B3-4B6E-BB9A-201519AF6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AC95EFF-B7CF-4642-A59B-D594D26AF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B28D136-25F2-4091-894B-B6FCC8A0F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9883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A48510-76D3-4516-8DA4-0F87957707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CB23291-F3EE-40AF-A6D1-F649A68F44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754F092-3612-4ADD-9716-8C682FCDC1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4FC29F4-EB49-40CD-9629-2CB84B8A7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9AC1B3E-E187-41D7-AEEF-DF0427872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688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FC7F06-F350-424D-AB68-09FF236C33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3EAA9CA-BC07-4C3F-8CF5-952FD6C92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D62D5E-83AA-4D0C-9DB8-E10F39288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CF09CB0-79E5-4B31-8DE1-7FB22C257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777F77-7C89-4E5E-AA26-A4036B1A7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9993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67481D-BBAD-4CA1-ACA8-9841A353E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1BA7972-04CE-4439-AED8-D6BF3BDB8D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3E61B93-E1A9-4003-BFC2-DFCEDAACD8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9FD9271-9D3D-47FC-A702-0D28F8EB6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1F2E8B3-049A-45EA-92BB-1587018ED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1C3249-67FF-436B-9CF5-B47F1E838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7142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A5E4EC-F39F-4530-A802-9575AD5F6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2D9137B-B158-43D3-B286-C90A7E5BE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4D29EC5-2F28-495D-9589-1D295A6AB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68665386-D800-4AF8-97A8-CFEFD505D5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BD330DE-20CD-4A65-B06A-EB7F7C0B17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0D0A1CA-2194-4E99-A5C7-E8B865493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52B2D18-E2A8-4A6A-B7FA-4708867C5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7F64956-DAEC-4307-A29D-ED3DF13E20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2373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987823-931C-44A4-B989-5858D87FC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046686C-76D5-4AC3-9A4C-1172F0816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474FC60F-AE82-4A05-8A5D-822B2A692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10E3FC4-2137-4BF2-BF6A-6CFF74DB8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3269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CC4C754-A251-4B96-B1A4-6452EA0B7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E2E3B48-E792-4F07-8F29-3C99F486C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6D28208-0930-427F-B514-447A3333C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4201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F7045D-816F-47AD-89C5-E73AC679BE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61F8511-CF8D-4533-89EE-F3E8D6B2D8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8E57404-8CA5-4461-BABA-72269BCDBC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39CC973-9BC4-42DF-9059-F599F5083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108081C-D8D8-4767-8376-DD7BB5C2C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198B86-CA3C-4519-BBDB-BEB743984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2078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FC74ACC-63B8-402B-B2B1-29DCDF929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B77010C-C925-4792-9705-9B0E097E3B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8446A88-DF1B-4A42-9D62-739811023F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60EF694-D543-4431-995C-59EC0D872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5A418C8-6E98-4A98-8680-F9C3DD2EF9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9DF9A29-74D2-44DD-9CE8-4198EA5A5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203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A4DE6C34-663A-402D-83CD-B6DB9EE25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E9007E-1926-4383-81EC-7F88E5D591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13540D-C539-46A2-A8A1-947FC36FA7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95FCB8-E98D-46AC-8944-D94C26489DE6}" type="datetimeFigureOut">
              <a:rPr lang="fr-FR" smtClean="0"/>
              <a:t>14/12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649C59E-2F17-4554-8076-CF64B668E6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340CE95-2E15-4CAC-960B-76F43BD2E7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5C471B-81C6-48E7-A882-E115296BEDE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4334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7.bin"/><Relationship Id="rId9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FC1472F1-EFEA-40B4-E342-43F2DA9170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64159"/>
            <a:ext cx="9800155" cy="6555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554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169268A4-9F34-473A-96FB-1048386E4306}"/>
              </a:ext>
            </a:extLst>
          </p:cNvPr>
          <p:cNvSpPr txBox="1"/>
          <p:nvPr/>
        </p:nvSpPr>
        <p:spPr>
          <a:xfrm>
            <a:off x="0" y="5910405"/>
            <a:ext cx="123004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igure S2. Gene expression of IL-6 (A), TNF-</a:t>
            </a:r>
            <a:r>
              <a:rPr lang="el-GR" dirty="0"/>
              <a:t>α</a:t>
            </a:r>
            <a:r>
              <a:rPr lang="fr-FR" dirty="0"/>
              <a:t> (B) and </a:t>
            </a:r>
            <a:r>
              <a:rPr lang="fr-FR" dirty="0" err="1"/>
              <a:t>adiponectin</a:t>
            </a:r>
            <a:r>
              <a:rPr lang="fr-FR" dirty="0"/>
              <a:t> (C) in the colon at 9-weeks of </a:t>
            </a:r>
            <a:r>
              <a:rPr lang="fr-FR" dirty="0" err="1"/>
              <a:t>diet</a:t>
            </a:r>
            <a:r>
              <a:rPr lang="fr-FR" dirty="0"/>
              <a:t> (4-5 mouse per </a:t>
            </a:r>
            <a:r>
              <a:rPr lang="fr-FR" dirty="0" err="1"/>
              <a:t>diet</a:t>
            </a:r>
            <a:r>
              <a:rPr lang="fr-FR" dirty="0"/>
              <a:t> and time). </a:t>
            </a:r>
            <a:r>
              <a:rPr lang="en-US" dirty="0"/>
              <a:t>All data are presented as mean ± standard error of the mean (SEM), n = 4-5</a:t>
            </a:r>
            <a:r>
              <a:rPr lang="fr-FR" dirty="0"/>
              <a:t> mouse per </a:t>
            </a:r>
            <a:r>
              <a:rPr lang="fr-FR" dirty="0" err="1"/>
              <a:t>diet</a:t>
            </a:r>
            <a:r>
              <a:rPr lang="fr-FR" dirty="0"/>
              <a:t> group and time.</a:t>
            </a:r>
            <a:r>
              <a:rPr lang="en-US" dirty="0"/>
              <a:t> </a:t>
            </a:r>
            <a:endParaRPr lang="fr-FR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67B51897-2EF1-4481-B1C7-84D46729F89C}"/>
              </a:ext>
            </a:extLst>
          </p:cNvPr>
          <p:cNvSpPr txBox="1"/>
          <p:nvPr/>
        </p:nvSpPr>
        <p:spPr>
          <a:xfrm>
            <a:off x="0" y="-15497"/>
            <a:ext cx="208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data</a:t>
            </a:r>
          </a:p>
        </p:txBody>
      </p:sp>
      <p:graphicFrame>
        <p:nvGraphicFramePr>
          <p:cNvPr id="4" name="Objet 3">
            <a:extLst>
              <a:ext uri="{FF2B5EF4-FFF2-40B4-BE49-F238E27FC236}">
                <a16:creationId xmlns:a16="http://schemas.microsoft.com/office/drawing/2014/main" id="{C81A571A-8109-4692-A86E-0F9D6011C7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4051689"/>
              </p:ext>
            </p:extLst>
          </p:nvPr>
        </p:nvGraphicFramePr>
        <p:xfrm>
          <a:off x="1093788" y="506413"/>
          <a:ext cx="4360862" cy="267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4176000" imgH="2556000" progId="Prism5.Document">
                  <p:embed/>
                </p:oleObj>
              </mc:Choice>
              <mc:Fallback>
                <p:oleObj name="Prism Project" r:id="rId2" imgW="4176000" imgH="2556000" progId="Prism5.Document">
                  <p:embed/>
                  <p:pic>
                    <p:nvPicPr>
                      <p:cNvPr id="4" name="Objet 3">
                        <a:extLst>
                          <a:ext uri="{FF2B5EF4-FFF2-40B4-BE49-F238E27FC236}">
                            <a16:creationId xmlns:a16="http://schemas.microsoft.com/office/drawing/2014/main" id="{C81A571A-8109-4692-A86E-0F9D6011C7F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93788" y="506413"/>
                        <a:ext cx="4360862" cy="267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234E9225-D746-AA2F-3804-E84B3E68B7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636797"/>
              </p:ext>
            </p:extLst>
          </p:nvPr>
        </p:nvGraphicFramePr>
        <p:xfrm>
          <a:off x="5586413" y="523665"/>
          <a:ext cx="4321175" cy="264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4176000" imgH="2556000" progId="Prism5.Document">
                  <p:embed/>
                </p:oleObj>
              </mc:Choice>
              <mc:Fallback>
                <p:oleObj name="Prism Project" r:id="rId4" imgW="4176000" imgH="2556000" progId="Prism5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234E9225-D746-AA2F-3804-E84B3E68B7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586413" y="523665"/>
                        <a:ext cx="4321175" cy="264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8BEF7053-BA3D-B22B-620B-18FA52A89EE7}"/>
              </a:ext>
            </a:extLst>
          </p:cNvPr>
          <p:cNvSpPr txBox="1"/>
          <p:nvPr/>
        </p:nvSpPr>
        <p:spPr>
          <a:xfrm>
            <a:off x="2974962" y="3076984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8" name="Objet 7">
            <a:extLst>
              <a:ext uri="{FF2B5EF4-FFF2-40B4-BE49-F238E27FC236}">
                <a16:creationId xmlns:a16="http://schemas.microsoft.com/office/drawing/2014/main" id="{B08C1DD8-841F-F4CC-45BA-8F0040C70A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4243408"/>
              </p:ext>
            </p:extLst>
          </p:nvPr>
        </p:nvGraphicFramePr>
        <p:xfrm>
          <a:off x="3168650" y="3151188"/>
          <a:ext cx="4406900" cy="2697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4176000" imgH="2556000" progId="Prism5.Document">
                  <p:embed/>
                </p:oleObj>
              </mc:Choice>
              <mc:Fallback>
                <p:oleObj name="Prism Project" r:id="rId6" imgW="4176000" imgH="2556000" progId="Prism5.Document">
                  <p:embed/>
                  <p:pic>
                    <p:nvPicPr>
                      <p:cNvPr id="8" name="Objet 7">
                        <a:extLst>
                          <a:ext uri="{FF2B5EF4-FFF2-40B4-BE49-F238E27FC236}">
                            <a16:creationId xmlns:a16="http://schemas.microsoft.com/office/drawing/2014/main" id="{B08C1DD8-841F-F4CC-45BA-8F0040C70A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68650" y="3151188"/>
                        <a:ext cx="4406900" cy="2697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52FA42BE-F508-1034-FCD8-6E54A982548D}"/>
              </a:ext>
            </a:extLst>
          </p:cNvPr>
          <p:cNvSpPr txBox="1"/>
          <p:nvPr/>
        </p:nvSpPr>
        <p:spPr>
          <a:xfrm>
            <a:off x="5347082" y="382061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A887012-43A1-8C40-CB2E-48BB5366D411}"/>
              </a:ext>
            </a:extLst>
          </p:cNvPr>
          <p:cNvSpPr txBox="1"/>
          <p:nvPr/>
        </p:nvSpPr>
        <p:spPr>
          <a:xfrm>
            <a:off x="998457" y="382061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772043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BD45A015-9F31-4AEA-96EA-EA1CA3B25D25}"/>
              </a:ext>
            </a:extLst>
          </p:cNvPr>
          <p:cNvSpPr/>
          <p:nvPr/>
        </p:nvSpPr>
        <p:spPr>
          <a:xfrm>
            <a:off x="5085806" y="2577737"/>
            <a:ext cx="740228" cy="4789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922B94C-31EF-4908-8DB3-DC36C95D4CC0}"/>
              </a:ext>
            </a:extLst>
          </p:cNvPr>
          <p:cNvSpPr/>
          <p:nvPr/>
        </p:nvSpPr>
        <p:spPr>
          <a:xfrm>
            <a:off x="8238120" y="2111828"/>
            <a:ext cx="740228" cy="4789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00B15B2-DCB1-4A22-BBE8-49563A1EE247}"/>
              </a:ext>
            </a:extLst>
          </p:cNvPr>
          <p:cNvSpPr/>
          <p:nvPr/>
        </p:nvSpPr>
        <p:spPr>
          <a:xfrm>
            <a:off x="7358743" y="2290354"/>
            <a:ext cx="644434" cy="7663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E90E289-DEDE-4D32-80C7-6D17348C78A2}"/>
              </a:ext>
            </a:extLst>
          </p:cNvPr>
          <p:cNvSpPr/>
          <p:nvPr/>
        </p:nvSpPr>
        <p:spPr>
          <a:xfrm>
            <a:off x="130664" y="5408703"/>
            <a:ext cx="121391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/>
              <a:t>Figure S3. Colon </a:t>
            </a:r>
            <a:r>
              <a:rPr lang="fr-FR" dirty="0" err="1"/>
              <a:t>gene</a:t>
            </a:r>
            <a:r>
              <a:rPr lang="fr-FR" dirty="0"/>
              <a:t> expression of claudin-1 (A) and  </a:t>
            </a:r>
            <a:r>
              <a:rPr lang="fr-FR" dirty="0" err="1"/>
              <a:t>occludin</a:t>
            </a:r>
            <a:r>
              <a:rPr lang="fr-FR" dirty="0"/>
              <a:t> (B) at 9-weeks </a:t>
            </a:r>
            <a:r>
              <a:rPr lang="fr-FR" dirty="0" err="1"/>
              <a:t>diet</a:t>
            </a:r>
            <a:r>
              <a:rPr lang="fr-FR" dirty="0"/>
              <a:t>. </a:t>
            </a:r>
            <a:r>
              <a:rPr lang="en-US" dirty="0"/>
              <a:t>Data are represented as the mean ± standard error of the mean (SEM), n = </a:t>
            </a:r>
            <a:r>
              <a:rPr lang="fr-FR" dirty="0"/>
              <a:t>5 mouse per </a:t>
            </a:r>
            <a:r>
              <a:rPr lang="fr-FR" dirty="0" err="1"/>
              <a:t>diet</a:t>
            </a:r>
            <a:r>
              <a:rPr lang="fr-FR" dirty="0"/>
              <a:t> group and time</a:t>
            </a:r>
            <a:r>
              <a:rPr lang="en-US" dirty="0"/>
              <a:t>.</a:t>
            </a:r>
            <a:endParaRPr lang="fr-FR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2291076-5333-46C7-ABAB-1463F81D36B4}"/>
              </a:ext>
            </a:extLst>
          </p:cNvPr>
          <p:cNvSpPr txBox="1"/>
          <p:nvPr/>
        </p:nvSpPr>
        <p:spPr>
          <a:xfrm>
            <a:off x="6868144" y="525967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ADA02EA0-F1AF-4BA1-A070-D530E4B5470D}"/>
              </a:ext>
            </a:extLst>
          </p:cNvPr>
          <p:cNvSpPr txBox="1"/>
          <p:nvPr/>
        </p:nvSpPr>
        <p:spPr>
          <a:xfrm>
            <a:off x="826645" y="525967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8572E0F2-1A68-4F5E-83C7-3A7E68A9263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3578093"/>
              </p:ext>
            </p:extLst>
          </p:nvPr>
        </p:nvGraphicFramePr>
        <p:xfrm>
          <a:off x="995363" y="774700"/>
          <a:ext cx="5440362" cy="332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4176000" imgH="2556000" progId="Prism5.Document">
                  <p:embed/>
                </p:oleObj>
              </mc:Choice>
              <mc:Fallback>
                <p:oleObj name="Prism Project" r:id="rId2" imgW="4176000" imgH="2556000" progId="Prism5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8572E0F2-1A68-4F5E-83C7-3A7E68A9263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95363" y="774700"/>
                        <a:ext cx="5440362" cy="3327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7151D7C1-ADAA-45A9-A1AD-78D3D352F2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973142"/>
              </p:ext>
            </p:extLst>
          </p:nvPr>
        </p:nvGraphicFramePr>
        <p:xfrm>
          <a:off x="6851650" y="847304"/>
          <a:ext cx="5330825" cy="325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4176000" imgH="2556000" progId="Prism5.Document">
                  <p:embed/>
                </p:oleObj>
              </mc:Choice>
              <mc:Fallback>
                <p:oleObj name="Prism Project" r:id="rId4" imgW="4176000" imgH="2556000" progId="Prism5.Document">
                  <p:embed/>
                  <p:pic>
                    <p:nvPicPr>
                      <p:cNvPr id="6" name="Objet 5">
                        <a:extLst>
                          <a:ext uri="{FF2B5EF4-FFF2-40B4-BE49-F238E27FC236}">
                            <a16:creationId xmlns:a16="http://schemas.microsoft.com/office/drawing/2014/main" id="{7151D7C1-ADAA-45A9-A1AD-78D3D352F2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851650" y="847304"/>
                        <a:ext cx="5330825" cy="325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4D9CC1EA-D1E7-B726-7156-27EEB90CFC2C}"/>
              </a:ext>
            </a:extLst>
          </p:cNvPr>
          <p:cNvSpPr txBox="1"/>
          <p:nvPr/>
        </p:nvSpPr>
        <p:spPr>
          <a:xfrm>
            <a:off x="0" y="-15497"/>
            <a:ext cx="208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1826520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154BE02F-C2BF-44F9-9622-F9D0A365A1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1849866"/>
              </p:ext>
            </p:extLst>
          </p:nvPr>
        </p:nvGraphicFramePr>
        <p:xfrm>
          <a:off x="6446838" y="658813"/>
          <a:ext cx="4176712" cy="255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4176000" imgH="2556000" progId="Prism5.Document">
                  <p:embed/>
                </p:oleObj>
              </mc:Choice>
              <mc:Fallback>
                <p:oleObj name="Prism Project" r:id="rId2" imgW="4176000" imgH="2556000" progId="Prism5.Document">
                  <p:embed/>
                  <p:pic>
                    <p:nvPicPr>
                      <p:cNvPr id="2" name="Objet 1">
                        <a:extLst>
                          <a:ext uri="{FF2B5EF4-FFF2-40B4-BE49-F238E27FC236}">
                            <a16:creationId xmlns:a16="http://schemas.microsoft.com/office/drawing/2014/main" id="{154BE02F-C2BF-44F9-9622-F9D0A365A1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446838" y="658813"/>
                        <a:ext cx="4176712" cy="255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E7B56B25-F0D6-451E-9DBF-A496A251FF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7345900"/>
              </p:ext>
            </p:extLst>
          </p:nvPr>
        </p:nvGraphicFramePr>
        <p:xfrm>
          <a:off x="6433008" y="3432175"/>
          <a:ext cx="4176712" cy="255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4176000" imgH="2556000" progId="Prism5.Document">
                  <p:embed/>
                </p:oleObj>
              </mc:Choice>
              <mc:Fallback>
                <p:oleObj name="Prism Project" r:id="rId4" imgW="4176000" imgH="2556000" progId="Prism5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E7B56B25-F0D6-451E-9DBF-A496A251FF7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33008" y="3432175"/>
                        <a:ext cx="4176712" cy="255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46A4A3F6-5E44-4FB1-B580-4997DAC09CF1}"/>
              </a:ext>
            </a:extLst>
          </p:cNvPr>
          <p:cNvSpPr txBox="1"/>
          <p:nvPr/>
        </p:nvSpPr>
        <p:spPr>
          <a:xfrm>
            <a:off x="0" y="-15497"/>
            <a:ext cx="208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dat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D0069E7-9CC3-4260-B6BB-9C4C978ABA3C}"/>
              </a:ext>
            </a:extLst>
          </p:cNvPr>
          <p:cNvSpPr/>
          <p:nvPr/>
        </p:nvSpPr>
        <p:spPr>
          <a:xfrm>
            <a:off x="137427" y="5870953"/>
            <a:ext cx="121391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/>
              <a:t>Figure S4. Gene expression </a:t>
            </a:r>
            <a:r>
              <a:rPr lang="fr-FR" dirty="0" err="1"/>
              <a:t>levels</a:t>
            </a:r>
            <a:r>
              <a:rPr lang="fr-FR" dirty="0"/>
              <a:t> of IL-1 </a:t>
            </a:r>
            <a:r>
              <a:rPr lang="el-GR" dirty="0"/>
              <a:t>β</a:t>
            </a:r>
            <a:r>
              <a:rPr lang="fr-FR" dirty="0"/>
              <a:t> and IL-6 in </a:t>
            </a:r>
            <a:r>
              <a:rPr lang="fr-FR" dirty="0" err="1"/>
              <a:t>liver</a:t>
            </a:r>
            <a:r>
              <a:rPr lang="fr-FR" dirty="0"/>
              <a:t> (A-B) and </a:t>
            </a:r>
            <a:r>
              <a:rPr lang="fr-FR" dirty="0" err="1"/>
              <a:t>mesenteric</a:t>
            </a:r>
            <a:r>
              <a:rPr lang="fr-FR" dirty="0"/>
              <a:t> tissues (C-D) at 9-weeks </a:t>
            </a:r>
            <a:r>
              <a:rPr lang="fr-FR" dirty="0" err="1"/>
              <a:t>diet</a:t>
            </a:r>
            <a:r>
              <a:rPr lang="fr-FR" dirty="0"/>
              <a:t>. </a:t>
            </a:r>
            <a:r>
              <a:rPr lang="en-US" dirty="0"/>
              <a:t>Data are represented as the mean ± standard error of the mean (SEM), n = </a:t>
            </a:r>
            <a:r>
              <a:rPr lang="fr-FR" dirty="0"/>
              <a:t>5 mouse per </a:t>
            </a:r>
            <a:r>
              <a:rPr lang="fr-FR" dirty="0" err="1"/>
              <a:t>diet</a:t>
            </a:r>
            <a:r>
              <a:rPr lang="fr-FR" dirty="0"/>
              <a:t> group </a:t>
            </a:r>
            <a:r>
              <a:rPr lang="fr-FR"/>
              <a:t>and time</a:t>
            </a:r>
            <a:r>
              <a:rPr lang="en-US"/>
              <a:t>.</a:t>
            </a:r>
            <a:endParaRPr lang="fr-FR" dirty="0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009CDC56-CF82-4808-9B7D-65A6908C554E}"/>
              </a:ext>
            </a:extLst>
          </p:cNvPr>
          <p:cNvSpPr txBox="1"/>
          <p:nvPr/>
        </p:nvSpPr>
        <p:spPr>
          <a:xfrm>
            <a:off x="6200231" y="356896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5D72E56-5943-40ED-8209-20AB4758BC55}"/>
              </a:ext>
            </a:extLst>
          </p:cNvPr>
          <p:cNvSpPr txBox="1"/>
          <p:nvPr/>
        </p:nvSpPr>
        <p:spPr>
          <a:xfrm>
            <a:off x="2363649" y="3392457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2EB90ED3-6D59-4644-B2BF-2C25D43CC71C}"/>
              </a:ext>
            </a:extLst>
          </p:cNvPr>
          <p:cNvSpPr txBox="1"/>
          <p:nvPr/>
        </p:nvSpPr>
        <p:spPr>
          <a:xfrm>
            <a:off x="6206994" y="3315465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D90268AA-94E6-43AA-8B32-7C501556ADC4}"/>
              </a:ext>
            </a:extLst>
          </p:cNvPr>
          <p:cNvSpPr txBox="1"/>
          <p:nvPr/>
        </p:nvSpPr>
        <p:spPr>
          <a:xfrm>
            <a:off x="2503987" y="356432"/>
            <a:ext cx="42862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12" name="Objet 11">
            <a:extLst>
              <a:ext uri="{FF2B5EF4-FFF2-40B4-BE49-F238E27FC236}">
                <a16:creationId xmlns:a16="http://schemas.microsoft.com/office/drawing/2014/main" id="{31D32F5D-7E12-45A3-B870-5811D45377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625413"/>
              </p:ext>
            </p:extLst>
          </p:nvPr>
        </p:nvGraphicFramePr>
        <p:xfrm>
          <a:off x="2538491" y="3412686"/>
          <a:ext cx="4284662" cy="255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6" imgW="4284000" imgH="2556000" progId="Prism5.Document">
                  <p:embed/>
                </p:oleObj>
              </mc:Choice>
              <mc:Fallback>
                <p:oleObj name="Prism Project" r:id="rId6" imgW="4284000" imgH="255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38491" y="3412686"/>
                        <a:ext cx="4284662" cy="255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t 12">
            <a:extLst>
              <a:ext uri="{FF2B5EF4-FFF2-40B4-BE49-F238E27FC236}">
                <a16:creationId xmlns:a16="http://schemas.microsoft.com/office/drawing/2014/main" id="{51BE5972-5795-4552-8813-9413E9CEF6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7828150"/>
              </p:ext>
            </p:extLst>
          </p:nvPr>
        </p:nvGraphicFramePr>
        <p:xfrm>
          <a:off x="2639114" y="650187"/>
          <a:ext cx="4176712" cy="2555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8" imgW="4176000" imgH="2556000" progId="Prism5.Document">
                  <p:embed/>
                </p:oleObj>
              </mc:Choice>
              <mc:Fallback>
                <p:oleObj name="Prism Project" r:id="rId8" imgW="4176000" imgH="255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39114" y="650187"/>
                        <a:ext cx="4176712" cy="2555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022797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8F498F89-6082-4585-8004-424785EA689C}"/>
              </a:ext>
            </a:extLst>
          </p:cNvPr>
          <p:cNvSpPr txBox="1"/>
          <p:nvPr/>
        </p:nvSpPr>
        <p:spPr>
          <a:xfrm>
            <a:off x="849745" y="359331"/>
            <a:ext cx="3755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1 : Complete diet compositions</a:t>
            </a:r>
            <a:endParaRPr lang="fr-FR" dirty="0"/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8B82E81A-DD3D-40FA-ACD3-C874DBBB52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7059" y="1127015"/>
            <a:ext cx="6418649" cy="53729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074702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0</TotalTime>
  <Words>177</Words>
  <Application>Microsoft Office PowerPoint</Application>
  <PresentationFormat>Grand écran</PresentationFormat>
  <Paragraphs>16</Paragraphs>
  <Slides>5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ism Projec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Luc Olivier</dc:creator>
  <cp:lastModifiedBy>Jean-Luc Olivier</cp:lastModifiedBy>
  <cp:revision>120</cp:revision>
  <cp:lastPrinted>2022-07-11T07:47:27Z</cp:lastPrinted>
  <dcterms:created xsi:type="dcterms:W3CDTF">2022-01-03T19:58:28Z</dcterms:created>
  <dcterms:modified xsi:type="dcterms:W3CDTF">2022-12-14T18:58:25Z</dcterms:modified>
</cp:coreProperties>
</file>